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2598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5804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8111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8585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23790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0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288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88538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26132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91021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885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0503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2ECC40-4C37-4AAB-B992-398C5862C12D}" type="datetimeFigureOut">
              <a:rPr kumimoji="1" lang="ja-JP" altLang="en-US" smtClean="0"/>
              <a:t>2025/10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67B2A8C-447F-44F8-B058-9AD208043CD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6726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ED0ABC2-2F35-D02A-7B3C-B5B1E69E7943}"/>
              </a:ext>
            </a:extLst>
          </p:cNvPr>
          <p:cNvSpPr txBox="1"/>
          <p:nvPr/>
        </p:nvSpPr>
        <p:spPr>
          <a:xfrm>
            <a:off x="549000" y="6642333"/>
            <a:ext cx="5760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</a:t>
            </a:r>
          </a:p>
          <a:p>
            <a:pPr algn="just"/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s of candesartan and telmisartan on the proliferation of bladder cancer cells in vitro. Proliferative responses of angiotensin II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gII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ype 1 receptor overexpressing T24 cells were assessed after 72 h of treatment with varying concentrations of losartan (left), candesartan (middle), and telmisartan (right). Data are presented as mean ± SEM of percent proliferation relative to non-treated controls (</a:t>
            </a:r>
            <a:r>
              <a:rPr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4). *p &lt; 0.05, compared with non-treated control by one-way ANOVA with Dunnett’s multiple comparison test.</a:t>
            </a: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6BEFF8E5-6050-4EE2-3899-ECECADF443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9948" y="1878672"/>
            <a:ext cx="6158103" cy="33756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70786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3</TotalTime>
  <Words>94</Words>
  <Application>Microsoft Office PowerPoint</Application>
  <PresentationFormat>A4 210 x 297 mm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神沼　修</dc:creator>
  <cp:lastModifiedBy>神沼　修</cp:lastModifiedBy>
  <cp:revision>10</cp:revision>
  <dcterms:created xsi:type="dcterms:W3CDTF">2025-07-04T02:55:30Z</dcterms:created>
  <dcterms:modified xsi:type="dcterms:W3CDTF">2025-10-23T01:12:23Z</dcterms:modified>
</cp:coreProperties>
</file>